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2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0" userDrawn="1">
          <p15:clr>
            <a:srgbClr val="A4A3A4"/>
          </p15:clr>
        </p15:guide>
        <p15:guide id="2" pos="21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1590"/>
  </p:normalViewPr>
  <p:slideViewPr>
    <p:cSldViewPr snapToGrid="0" snapToObjects="1" showGuides="1">
      <p:cViewPr>
        <p:scale>
          <a:sx n="68" d="100"/>
          <a:sy n="68" d="100"/>
        </p:scale>
        <p:origin x="984" y="832"/>
      </p:cViewPr>
      <p:guideLst>
        <p:guide orient="horz" pos="360"/>
        <p:guide pos="21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B26737-FF8B-6D4D-8E20-918A2034C615}" type="datetimeFigureOut">
              <a:rPr lang="en-US" smtClean="0"/>
              <a:t>12/13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DFA975-766D-D04E-BD9D-48AD8220E1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4241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DFA975-766D-D04E-BD9D-48AD8220E16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87917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Supplemental Table 1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DFA975-766D-D04E-BD9D-48AD8220E16F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9185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93F7D3-B188-DE4B-AB31-C6B81BE98DC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B8317C0-F9FA-7E45-8407-79127E22A2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7205D9-AE53-4546-92F1-7E54E17793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2ADCC-9997-0C43-81B4-928E42C001F1}" type="datetimeFigureOut">
              <a:rPr lang="en-US" smtClean="0"/>
              <a:t>12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62AC91-2ED2-1045-8BDE-F06B98210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B62900-B359-A145-A495-5D765A2E89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5584B-9936-8841-ABC5-F273F6D66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540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B1CDCE-9FAB-764F-921D-E35E510DF1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34F7C40-A050-E34B-8753-D282B75B07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36FA55-33F3-FC44-8EC3-48B4B5F97A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2ADCC-9997-0C43-81B4-928E42C001F1}" type="datetimeFigureOut">
              <a:rPr lang="en-US" smtClean="0"/>
              <a:t>12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1B16E0-D67E-C14B-84B4-D8E2535E1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A71FBD-7D26-7448-AFFF-FDC19EF26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5584B-9936-8841-ABC5-F273F6D66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2444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BA953D9-AA45-DF4E-8DAD-4A660D575EB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B959BE-5924-6D43-9BD3-A3F19E8A38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41F173-FC72-EE41-9484-BA1F7BFCE7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2ADCC-9997-0C43-81B4-928E42C001F1}" type="datetimeFigureOut">
              <a:rPr lang="en-US" smtClean="0"/>
              <a:t>12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16B98C-7E37-1C41-A908-F5F386F10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1ABE07-4E0C-104F-8EEB-BBD5745DFD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5584B-9936-8841-ABC5-F273F6D66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422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F24CBC-7D0A-4D47-AC54-A4BF5A7096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D65023-2FFB-B74E-BE2B-9C92BA2520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CD2A1A-A7F8-8D40-B050-66F526BEA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2ADCC-9997-0C43-81B4-928E42C001F1}" type="datetimeFigureOut">
              <a:rPr lang="en-US" smtClean="0"/>
              <a:t>12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F0AF0D-1B01-A248-AF3B-DBC6805F0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1CD4E4-A79C-AF4C-8863-07BF4644BB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5584B-9936-8841-ABC5-F273F6D66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410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796AA9-60E6-E742-9C0B-912E48AFE0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DA7A56-3BD7-BD4B-AC68-96186D5EDD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4CB18D-4D27-BF43-A848-548276840C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2ADCC-9997-0C43-81B4-928E42C001F1}" type="datetimeFigureOut">
              <a:rPr lang="en-US" smtClean="0"/>
              <a:t>12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66EB4A-211B-234F-9F9D-56516FFE9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FA4C14-C2CF-3F41-A06B-AAA4EF8152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5584B-9936-8841-ABC5-F273F6D66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861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AA12FC-1AAA-2542-9ED7-18164ABA53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12DE82-E71E-864B-8FC6-2F6BD7F6E5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0B3742-3928-F44A-8269-F2113C5FB9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9130D0-F619-344F-8BA8-8D4C5AB23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2ADCC-9997-0C43-81B4-928E42C001F1}" type="datetimeFigureOut">
              <a:rPr lang="en-US" smtClean="0"/>
              <a:t>12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0D66D0-65FA-E143-9757-448DD0269D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A9954D-9852-CC45-AB0A-6E6F2AB6D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5584B-9936-8841-ABC5-F273F6D66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6940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C547AB-989A-DD47-AF92-5ABE84E1FF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1EAB43-77E3-4443-A9C4-C016945803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BE26D9-C541-DB49-8D2A-6E138559BF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56BF29-1AC3-F149-8992-36813D1C3D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67F8D92-D37B-E840-94D4-2A2B89E556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7B23F21-BC93-004A-B67F-50EB4DA36D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2ADCC-9997-0C43-81B4-928E42C001F1}" type="datetimeFigureOut">
              <a:rPr lang="en-US" smtClean="0"/>
              <a:t>12/13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488F03-3A67-CE4E-A4C0-A325B51DA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387EE58-9B6B-2A42-814D-3F11B42E25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5584B-9936-8841-ABC5-F273F6D66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32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046CB0-C3C9-DF45-A954-05B124F1BA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A8C66A-399D-FB41-B965-5B80A4075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2ADCC-9997-0C43-81B4-928E42C001F1}" type="datetimeFigureOut">
              <a:rPr lang="en-US" smtClean="0"/>
              <a:t>12/13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30BEA7E-3739-7C47-83D2-E0BED1174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DB32A2-D2CC-914A-A205-83D3950AEB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5584B-9936-8841-ABC5-F273F6D66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780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89217C4-6521-E047-AB6A-7500865115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2ADCC-9997-0C43-81B4-928E42C001F1}" type="datetimeFigureOut">
              <a:rPr lang="en-US" smtClean="0"/>
              <a:t>12/13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F90F656-12C1-0A4D-BE65-8843BBFA4F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F626944-5917-B448-BBBC-644BF226E9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5584B-9936-8841-ABC5-F273F6D66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7534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17D97F-9ECA-0E4B-AB9E-03649192C8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F63818-D6E4-C14E-BA65-CDA1AC4A4A6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BFF50F-9A4B-E84A-A7C0-EBDF21B94B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133F09-ACF0-8F47-B881-7604A526A3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2ADCC-9997-0C43-81B4-928E42C001F1}" type="datetimeFigureOut">
              <a:rPr lang="en-US" smtClean="0"/>
              <a:t>12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DDE4EF-5308-DC4C-B81F-9B6052B96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7C45899-4B11-E643-8632-900528BC1C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5584B-9936-8841-ABC5-F273F6D66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949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81E7D2-E99A-9B48-B6A9-4516A1F12E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27CD48F-F823-454B-95F7-7720B84835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645F42-A1F9-A849-A807-DB3E4FD10D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85285A-F465-B942-BD38-FD3C40F7A0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52ADCC-9997-0C43-81B4-928E42C001F1}" type="datetimeFigureOut">
              <a:rPr lang="en-US" smtClean="0"/>
              <a:t>12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5B20A2-0A50-2740-9ABD-FEFA745600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BC29C2-7CE1-F74D-9722-B94E78C52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E5584B-9936-8841-ABC5-F273F6D66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960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474FF52-EB19-0344-8D1E-A51EDAEA26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CA9F11-4E5A-D94E-B6D3-61B5F0038A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640EC0-4936-474C-AC9A-2A7BDFF55F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52ADCC-9997-0C43-81B4-928E42C001F1}" type="datetimeFigureOut">
              <a:rPr lang="en-US" smtClean="0"/>
              <a:t>12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920A3B-8DCE-4549-A38E-76E3702325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C4AD3C-D235-C143-9F65-EABCC39149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E5584B-9936-8841-ABC5-F273F6D66A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5931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B6060D3-98AE-2A49-93D8-F17F5D95C3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100" y="342900"/>
            <a:ext cx="894488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89918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6A879CFE-E09D-C74B-94A4-4354AFC8BA4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9748193"/>
              </p:ext>
            </p:extLst>
          </p:nvPr>
        </p:nvGraphicFramePr>
        <p:xfrm>
          <a:off x="392775" y="601592"/>
          <a:ext cx="3419856" cy="43407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14995">
                  <a:extLst>
                    <a:ext uri="{9D8B030D-6E8A-4147-A177-3AD203B41FA5}">
                      <a16:colId xmlns:a16="http://schemas.microsoft.com/office/drawing/2014/main" val="1859702897"/>
                    </a:ext>
                  </a:extLst>
                </a:gridCol>
                <a:gridCol w="3104861">
                  <a:extLst>
                    <a:ext uri="{9D8B030D-6E8A-4147-A177-3AD203B41FA5}">
                      <a16:colId xmlns:a16="http://schemas.microsoft.com/office/drawing/2014/main" val="2582932259"/>
                    </a:ext>
                  </a:extLst>
                </a:gridCol>
              </a:tblGrid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242888" indent="-242888" algn="l" fontAlgn="ctr">
                        <a:lnSpc>
                          <a:spcPct val="100000"/>
                        </a:lnSpc>
                        <a:tabLst/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paired labial seal-diminished lip seal 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5636684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gual pumping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9468329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layed initiation of oral transport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8232403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paired lingual mobility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72448867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ngual stasis 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3203708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mature spillag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7974889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layed swallow respon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8426609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ent swallow respon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2242901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tention in vallecular after swallow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0608162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sal reflux-diminished velopharyngeal closur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8367500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iglottic closure 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2330327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ryngeal contraction 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2357729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ngue base retraction 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0736376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iecemeal deglutition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222497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eated swallows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3697450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oling/retention in vallecular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3088168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oling/retention in pyriform sinus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1353117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paired hyoid laryngeal elevation anteriorly vs superiorly and/or both 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30408850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tention in pyriform sinus after swallowing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77171144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normal bolus flow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8214038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ryngeal penetration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6292516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ryngeal segment opening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2633584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spiration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50607126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litional cough 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3409475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litional cough with material cleared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4110950"/>
                  </a:ext>
                </a:extLst>
              </a:tr>
              <a:tr h="166950">
                <a:tc>
                  <a:txBody>
                    <a:bodyPr/>
                    <a:lstStyle/>
                    <a:p>
                      <a:pPr algn="ctr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>
                        <a:lnSpc>
                          <a:spcPct val="100000"/>
                        </a:lnSpc>
                      </a:pPr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ryngeal wall stasis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580407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70076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899</TotalTime>
  <Words>126</Words>
  <Application>Microsoft Macintosh PowerPoint</Application>
  <PresentationFormat>Widescreen</PresentationFormat>
  <Paragraphs>56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noz, Andrea (NIH/NICHD) [F]</dc:creator>
  <cp:lastModifiedBy>Munoz, Andrea (NIH/NICHD) [F]</cp:lastModifiedBy>
  <cp:revision>28</cp:revision>
  <dcterms:created xsi:type="dcterms:W3CDTF">2021-08-18T13:07:06Z</dcterms:created>
  <dcterms:modified xsi:type="dcterms:W3CDTF">2021-12-13T14:50:02Z</dcterms:modified>
</cp:coreProperties>
</file>